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comments/comment2.xml" ContentType="application/vnd.openxmlformats-officedocument.presentationml.comments+xml"/>
  <Override PartName="/ppt/commentAuthors.xml" ContentType="application/vnd.openxmlformats-officedocument.presentationml.commentAuthors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12801600" cy="9601200"/>
  <p:notesSz cx="7088188" cy="10209213"/>
</p:presentation>
</file>

<file path=ppt/commentAuthors.xml><?xml version="1.0" encoding="utf-8"?>
<p:cmAuthorLst xmlns:p="http://schemas.openxmlformats.org/presentationml/2006/main">
  <p:cmAuthor id="0" name="Senior Editor" initials="SE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<Relationship Id="rId6" Type="http://schemas.openxmlformats.org/officeDocument/2006/relationships/commentAuthors" Target="commentAuthors.xml"/>
</Relationships>
</file>

<file path=ppt/comments/comment2.xml><?xml version="1.0" encoding="utf-8"?>
<p:cmLst xmlns:p="http://schemas.openxmlformats.org/presentationml/2006/main">
  <p:cm authorId="0" dt="2013-08-23T15:14:39.953000000" idx="1">
    <p:pos x="2119" y="60"/>
    <p:text>Please ensure that this and similar edits retain your intended meaning.</p:text>
  </p:cm>
</p:cmLst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C15127-C03E-47FE-9004-86CE5ACCD1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ctr">
            <a:noAutofit/>
          </a:bodyPr>
          <a:p>
            <a:pPr indent="0" algn="ctr"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39720" y="2241720"/>
            <a:ext cx="1152216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39720" y="5550120"/>
            <a:ext cx="1152216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01DFD-490F-4F7E-A4DA-4FEABD690A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ctr">
            <a:noAutofit/>
          </a:bodyPr>
          <a:p>
            <a:pPr indent="0" algn="ctr"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39720" y="2241720"/>
            <a:ext cx="562248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543720" y="2241720"/>
            <a:ext cx="562248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39720" y="5550120"/>
            <a:ext cx="562248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543720" y="5550120"/>
            <a:ext cx="562248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B1AFE-AE55-43A5-A7B2-6D8D0BDF22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ctr">
            <a:noAutofit/>
          </a:bodyPr>
          <a:p>
            <a:pPr indent="0" algn="ctr"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39720" y="2241720"/>
            <a:ext cx="370980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535280" y="2241720"/>
            <a:ext cx="370980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431200" y="2241720"/>
            <a:ext cx="370980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39720" y="5550120"/>
            <a:ext cx="370980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535280" y="5550120"/>
            <a:ext cx="370980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431200" y="5550120"/>
            <a:ext cx="370980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1C976A-0C1C-443B-81A1-58CBDEE01E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ctr">
            <a:noAutofit/>
          </a:bodyPr>
          <a:p>
            <a:pPr indent="0" algn="ctr"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39720" y="2241720"/>
            <a:ext cx="11522160" cy="6333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074"/>
              </a:spcBef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7D9D4-502B-44EE-8BC6-ED74F9AC10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ctr">
            <a:noAutofit/>
          </a:bodyPr>
          <a:p>
            <a:pPr indent="0" algn="ctr"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39720" y="2241720"/>
            <a:ext cx="11522160" cy="633384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E6A96-E7F1-4A10-8F6B-E24F302666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ctr">
            <a:noAutofit/>
          </a:bodyPr>
          <a:p>
            <a:pPr indent="0" algn="ctr"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39720" y="2241720"/>
            <a:ext cx="5622480" cy="633384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543720" y="2241720"/>
            <a:ext cx="5622480" cy="633384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6E832-059F-4803-B416-9611CAA4EF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ctr">
            <a:noAutofit/>
          </a:bodyPr>
          <a:p>
            <a:pPr indent="0" algn="ctr"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DB61A-9DD6-4243-B4F9-F29414DC29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39720" y="383760"/>
            <a:ext cx="1152216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074"/>
              </a:spcBef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0D18C-1166-423A-870E-3F7793A717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ctr">
            <a:noAutofit/>
          </a:bodyPr>
          <a:p>
            <a:pPr indent="0" algn="ctr"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39720" y="2241720"/>
            <a:ext cx="562248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543720" y="2241720"/>
            <a:ext cx="5622480" cy="633384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39720" y="5550120"/>
            <a:ext cx="562248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17FD81-F3DF-424E-8937-4D8731D3BF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ctr">
            <a:noAutofit/>
          </a:bodyPr>
          <a:p>
            <a:pPr indent="0" algn="ctr"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39720" y="2241720"/>
            <a:ext cx="5622480" cy="633384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543720" y="2241720"/>
            <a:ext cx="562248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543720" y="5550120"/>
            <a:ext cx="562248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90F81-63D3-462D-8F9D-7E8A5EDDCA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ctr">
            <a:noAutofit/>
          </a:bodyPr>
          <a:p>
            <a:pPr indent="0" algn="ctr"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39720" y="2241720"/>
            <a:ext cx="562248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543720" y="2241720"/>
            <a:ext cx="562248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39720" y="5550120"/>
            <a:ext cx="11522160" cy="30211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indent="0">
              <a:spcBef>
                <a:spcPts val="1074"/>
              </a:spcBef>
              <a:buNone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D73918-8355-4554-AA94-186786BDE0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39720" y="383760"/>
            <a:ext cx="11522160" cy="160020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ctr">
            <a:noAutofit/>
          </a:bodyPr>
          <a:p>
            <a:pPr indent="0" algn="ctr">
              <a:buNone/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0" lang="en-US" sz="5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5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39720" y="2241720"/>
            <a:ext cx="11522160" cy="633384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rmAutofit/>
          </a:bodyPr>
          <a:p>
            <a:pPr marL="458640" indent="-458640">
              <a:spcBef>
                <a:spcPts val="1074"/>
              </a:spcBef>
              <a:buClr>
                <a:srgbClr val="000000"/>
              </a:buClr>
              <a:buFont typeface="Arial"/>
              <a:buChar char="•"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  <a:p>
            <a:pPr lvl="1" marL="992160" indent="-380880">
              <a:spcBef>
                <a:spcPts val="1074"/>
              </a:spcBef>
              <a:buClr>
                <a:srgbClr val="000000"/>
              </a:buClr>
              <a:buFont typeface="Arial"/>
              <a:buChar char="–"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  <a:p>
            <a:pPr lvl="2" marL="1527120" indent="-304920">
              <a:spcBef>
                <a:spcPts val="1074"/>
              </a:spcBef>
              <a:buClr>
                <a:srgbClr val="000000"/>
              </a:buClr>
              <a:buFont typeface="Arial"/>
              <a:buChar char="•"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  <a:p>
            <a:pPr lvl="3" marL="2138400" indent="-304920">
              <a:spcBef>
                <a:spcPts val="1074"/>
              </a:spcBef>
              <a:buClr>
                <a:srgbClr val="000000"/>
              </a:buClr>
              <a:buFont typeface="Arial"/>
              <a:buChar char="–"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  <a:p>
            <a:pPr lvl="4" marL="2749680" indent="-306360">
              <a:spcBef>
                <a:spcPts val="1074"/>
              </a:spcBef>
              <a:buClr>
                <a:srgbClr val="000000"/>
              </a:buClr>
              <a:buFont typeface="Arial"/>
              <a:buChar char="»"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  <a:p>
            <a:pPr lvl="5" marL="2749680" indent="-306360">
              <a:spcBef>
                <a:spcPts val="1074"/>
              </a:spcBef>
              <a:buClr>
                <a:srgbClr val="000000"/>
              </a:buClr>
              <a:buFont typeface="Arial"/>
              <a:buChar char="»"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  <a:p>
            <a:pPr lvl="6" marL="2749680" indent="-306360">
              <a:spcBef>
                <a:spcPts val="1074"/>
              </a:spcBef>
              <a:buClr>
                <a:srgbClr val="000000"/>
              </a:buClr>
              <a:buFont typeface="Arial"/>
              <a:buChar char="»"/>
              <a:tabLst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4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39360" y="8741880"/>
            <a:ext cx="2987640" cy="6685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373640" y="8741880"/>
            <a:ext cx="4054320" cy="6685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173880" y="8741880"/>
            <a:ext cx="2987640" cy="668520"/>
          </a:xfrm>
          <a:prstGeom prst="rect">
            <a:avLst/>
          </a:prstGeom>
          <a:noFill/>
          <a:ln w="0">
            <a:noFill/>
          </a:ln>
        </p:spPr>
        <p:txBody>
          <a:bodyPr lIns="122040" rIns="122040" tIns="61200" bIns="612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1FFFB5-B08E-4BAF-B594-FA03900C6F0D}" type="slidenum">
              <a:rPr b="0" lang="es-ES" sz="1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omments" Target="../comments/commen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00"/>
          <p:cNvGrpSpPr/>
          <p:nvPr/>
        </p:nvGrpSpPr>
        <p:grpSpPr>
          <a:xfrm>
            <a:off x="1025640" y="1411200"/>
            <a:ext cx="10820160" cy="6350040"/>
            <a:chOff x="1025640" y="1411200"/>
            <a:chExt cx="10820160" cy="6350040"/>
          </a:xfrm>
        </p:grpSpPr>
        <p:sp>
          <p:nvSpPr>
            <p:cNvPr id="42" name="Rectangle 93"/>
            <p:cNvSpPr/>
            <p:nvPr/>
          </p:nvSpPr>
          <p:spPr>
            <a:xfrm>
              <a:off x="8645400" y="5208480"/>
              <a:ext cx="1803600" cy="507960"/>
            </a:xfrm>
            <a:prstGeom prst="rect">
              <a:avLst/>
            </a:prstGeom>
            <a:solidFill>
              <a:srgbClr val="66ff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92"/>
            <p:cNvSpPr/>
            <p:nvPr/>
          </p:nvSpPr>
          <p:spPr>
            <a:xfrm>
              <a:off x="3171960" y="5208480"/>
              <a:ext cx="1663560" cy="50796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Group 5"/>
            <p:cNvGrpSpPr/>
            <p:nvPr/>
          </p:nvGrpSpPr>
          <p:grpSpPr>
            <a:xfrm>
              <a:off x="6213600" y="5519520"/>
              <a:ext cx="1103760" cy="1580760"/>
              <a:chOff x="6213600" y="5519520"/>
              <a:chExt cx="1103760" cy="1580760"/>
            </a:xfrm>
          </p:grpSpPr>
          <p:sp>
            <p:nvSpPr>
              <p:cNvPr id="45" name="AutoShape 6"/>
              <p:cNvSpPr/>
              <p:nvPr/>
            </p:nvSpPr>
            <p:spPr>
              <a:xfrm>
                <a:off x="6562800" y="5871240"/>
                <a:ext cx="354960" cy="1229040"/>
              </a:xfrm>
              <a:prstGeom prst="downArrow">
                <a:avLst>
                  <a:gd name="adj1" fmla="val 50000"/>
                  <a:gd name="adj2" fmla="val 55079"/>
                </a:avLst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AutoShape 7"/>
              <p:cNvSpPr/>
              <p:nvPr/>
            </p:nvSpPr>
            <p:spPr>
              <a:xfrm rot="5400000">
                <a:off x="6217560" y="5515560"/>
                <a:ext cx="693360" cy="701280"/>
              </a:xfrm>
              <a:custGeom>
                <a:avLst/>
                <a:gdLst>
                  <a:gd name="textAreaLeft" fmla="*/ 399600 w 693360"/>
                  <a:gd name="textAreaRight" fmla="*/ 687600 w 693360"/>
                  <a:gd name="textAreaTop" fmla="*/ 102960 h 701280"/>
                  <a:gd name="textAreaBottom" fmla="*/ 291960 h 701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AutoShape 8"/>
              <p:cNvSpPr/>
              <p:nvPr/>
            </p:nvSpPr>
            <p:spPr>
              <a:xfrm flipH="1" rot="16200000">
                <a:off x="6571800" y="5467680"/>
                <a:ext cx="693360" cy="796680"/>
              </a:xfrm>
              <a:custGeom>
                <a:avLst/>
                <a:gdLst>
                  <a:gd name="textAreaLeft" fmla="*/ 399600 w 693360"/>
                  <a:gd name="textAreaRight" fmla="*/ 687600 w 693360"/>
                  <a:gd name="textAreaTop" fmla="*/ 117360 h 796680"/>
                  <a:gd name="textAreaBottom" fmla="*/ 331560 h 796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Group 9"/>
            <p:cNvGrpSpPr/>
            <p:nvPr/>
          </p:nvGrpSpPr>
          <p:grpSpPr>
            <a:xfrm>
              <a:off x="7762320" y="3576240"/>
              <a:ext cx="1105560" cy="1581120"/>
              <a:chOff x="7762320" y="3576240"/>
              <a:chExt cx="1105560" cy="1581120"/>
            </a:xfrm>
          </p:grpSpPr>
          <p:sp>
            <p:nvSpPr>
              <p:cNvPr id="49" name="AutoShape 10"/>
              <p:cNvSpPr/>
              <p:nvPr/>
            </p:nvSpPr>
            <p:spPr>
              <a:xfrm>
                <a:off x="8112240" y="3927960"/>
                <a:ext cx="355320" cy="1229400"/>
              </a:xfrm>
              <a:prstGeom prst="downArrow">
                <a:avLst>
                  <a:gd name="adj1" fmla="val 50000"/>
                  <a:gd name="adj2" fmla="val 55039"/>
                </a:avLst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AutoShape 11"/>
              <p:cNvSpPr/>
              <p:nvPr/>
            </p:nvSpPr>
            <p:spPr>
              <a:xfrm rot="5400000">
                <a:off x="7766280" y="3571920"/>
                <a:ext cx="693360" cy="701640"/>
              </a:xfrm>
              <a:custGeom>
                <a:avLst/>
                <a:gdLst>
                  <a:gd name="textAreaLeft" fmla="*/ 399600 w 693360"/>
                  <a:gd name="textAreaRight" fmla="*/ 687600 w 693360"/>
                  <a:gd name="textAreaTop" fmla="*/ 102960 h 701640"/>
                  <a:gd name="textAreaBottom" fmla="*/ 291960 h 701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AutoShape 12"/>
              <p:cNvSpPr/>
              <p:nvPr/>
            </p:nvSpPr>
            <p:spPr>
              <a:xfrm flipH="1" rot="16200000">
                <a:off x="8122680" y="3524400"/>
                <a:ext cx="693360" cy="797040"/>
              </a:xfrm>
              <a:custGeom>
                <a:avLst/>
                <a:gdLst>
                  <a:gd name="textAreaLeft" fmla="*/ 399600 w 693360"/>
                  <a:gd name="textAreaRight" fmla="*/ 687600 w 693360"/>
                  <a:gd name="textAreaTop" fmla="*/ 117360 h 797040"/>
                  <a:gd name="textAreaBottom" fmla="*/ 331920 h 7970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2" name="Group 13"/>
            <p:cNvGrpSpPr/>
            <p:nvPr/>
          </p:nvGrpSpPr>
          <p:grpSpPr>
            <a:xfrm>
              <a:off x="4650840" y="3576240"/>
              <a:ext cx="1105560" cy="1581120"/>
              <a:chOff x="4650840" y="3576240"/>
              <a:chExt cx="1105560" cy="1581120"/>
            </a:xfrm>
          </p:grpSpPr>
          <p:sp>
            <p:nvSpPr>
              <p:cNvPr id="53" name="AutoShape 14"/>
              <p:cNvSpPr/>
              <p:nvPr/>
            </p:nvSpPr>
            <p:spPr>
              <a:xfrm>
                <a:off x="5000760" y="3927960"/>
                <a:ext cx="355320" cy="1229400"/>
              </a:xfrm>
              <a:prstGeom prst="downArrow">
                <a:avLst>
                  <a:gd name="adj1" fmla="val 50000"/>
                  <a:gd name="adj2" fmla="val 55039"/>
                </a:avLst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AutoShape 15"/>
              <p:cNvSpPr/>
              <p:nvPr/>
            </p:nvSpPr>
            <p:spPr>
              <a:xfrm rot="5400000">
                <a:off x="4654800" y="3571920"/>
                <a:ext cx="693360" cy="701640"/>
              </a:xfrm>
              <a:custGeom>
                <a:avLst/>
                <a:gdLst>
                  <a:gd name="textAreaLeft" fmla="*/ 399600 w 693360"/>
                  <a:gd name="textAreaRight" fmla="*/ 687600 w 693360"/>
                  <a:gd name="textAreaTop" fmla="*/ 102960 h 701640"/>
                  <a:gd name="textAreaBottom" fmla="*/ 291960 h 7016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AutoShape 16"/>
              <p:cNvSpPr/>
              <p:nvPr/>
            </p:nvSpPr>
            <p:spPr>
              <a:xfrm flipH="1" rot="16200000">
                <a:off x="5011200" y="3524400"/>
                <a:ext cx="693360" cy="797040"/>
              </a:xfrm>
              <a:custGeom>
                <a:avLst/>
                <a:gdLst>
                  <a:gd name="textAreaLeft" fmla="*/ 399600 w 693360"/>
                  <a:gd name="textAreaRight" fmla="*/ 687600 w 693360"/>
                  <a:gd name="textAreaTop" fmla="*/ 117360 h 797040"/>
                  <a:gd name="textAreaBottom" fmla="*/ 331920 h 7970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" name="AutoShape 17"/>
            <p:cNvSpPr/>
            <p:nvPr/>
          </p:nvSpPr>
          <p:spPr>
            <a:xfrm>
              <a:off x="3463920" y="1919160"/>
              <a:ext cx="355680" cy="1307880"/>
            </a:xfrm>
            <a:prstGeom prst="downArrow">
              <a:avLst>
                <a:gd name="adj1" fmla="val 50000"/>
                <a:gd name="adj2" fmla="val 58493"/>
              </a:avLst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AutoShape 18"/>
            <p:cNvSpPr/>
            <p:nvPr/>
          </p:nvSpPr>
          <p:spPr>
            <a:xfrm>
              <a:off x="6588000" y="1919160"/>
              <a:ext cx="355680" cy="1307880"/>
            </a:xfrm>
            <a:prstGeom prst="downArrow">
              <a:avLst>
                <a:gd name="adj1" fmla="val 50000"/>
                <a:gd name="adj2" fmla="val 58493"/>
              </a:avLst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AutoShape 19"/>
            <p:cNvSpPr/>
            <p:nvPr/>
          </p:nvSpPr>
          <p:spPr>
            <a:xfrm>
              <a:off x="9674280" y="1919160"/>
              <a:ext cx="355680" cy="1307880"/>
            </a:xfrm>
            <a:prstGeom prst="downArrow">
              <a:avLst>
                <a:gd name="adj1" fmla="val 50000"/>
                <a:gd name="adj2" fmla="val 58493"/>
              </a:avLst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AutoShape 72"/>
            <p:cNvSpPr/>
            <p:nvPr/>
          </p:nvSpPr>
          <p:spPr>
            <a:xfrm>
              <a:off x="1025640" y="1411200"/>
              <a:ext cx="5371920" cy="507960"/>
            </a:xfrm>
            <a:prstGeom prst="hexagon">
              <a:avLst>
                <a:gd name="adj" fmla="val 31286"/>
                <a:gd name="vf" fmla="val 115470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p.V617F homozygous patient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Genomic DNA samp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AutoShape 73"/>
            <p:cNvSpPr/>
            <p:nvPr/>
          </p:nvSpPr>
          <p:spPr>
            <a:xfrm>
              <a:off x="6473880" y="1411200"/>
              <a:ext cx="5371920" cy="507960"/>
            </a:xfrm>
            <a:prstGeom prst="hexagon">
              <a:avLst>
                <a:gd name="adj" fmla="val 31286"/>
                <a:gd name="vf" fmla="val 115470"/>
              </a:avLst>
            </a:prstGeom>
            <a:solidFill>
              <a:srgbClr val="66ff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Wild-type individua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Genomic DNA samp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74"/>
            <p:cNvSpPr/>
            <p:nvPr/>
          </p:nvSpPr>
          <p:spPr>
            <a:xfrm>
              <a:off x="3007080" y="2130120"/>
              <a:ext cx="133272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g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75"/>
            <p:cNvSpPr/>
            <p:nvPr/>
          </p:nvSpPr>
          <p:spPr>
            <a:xfrm>
              <a:off x="3144960" y="2485800"/>
              <a:ext cx="106632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FOin + RO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76"/>
            <p:cNvSpPr/>
            <p:nvPr/>
          </p:nvSpPr>
          <p:spPr>
            <a:xfrm>
              <a:off x="9217440" y="2130120"/>
              <a:ext cx="133272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g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77"/>
            <p:cNvSpPr/>
            <p:nvPr/>
          </p:nvSpPr>
          <p:spPr>
            <a:xfrm>
              <a:off x="9329760" y="2485800"/>
              <a:ext cx="106632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FOin + RO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78"/>
            <p:cNvSpPr/>
            <p:nvPr/>
          </p:nvSpPr>
          <p:spPr>
            <a:xfrm>
              <a:off x="6137640" y="2130120"/>
              <a:ext cx="133272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g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79"/>
            <p:cNvSpPr/>
            <p:nvPr/>
          </p:nvSpPr>
          <p:spPr>
            <a:xfrm>
              <a:off x="5619600" y="2485800"/>
              <a:ext cx="231948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Up-Sp-gDNA + Lo-Sp-g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AutoShape 80"/>
            <p:cNvSpPr/>
            <p:nvPr/>
          </p:nvSpPr>
          <p:spPr>
            <a:xfrm>
              <a:off x="2663640" y="3277800"/>
              <a:ext cx="2006640" cy="508320"/>
            </a:xfrm>
            <a:prstGeom prst="hexagon">
              <a:avLst>
                <a:gd name="adj" fmla="val 0"/>
                <a:gd name="vf" fmla="val 115470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MT-left-ar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product (453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AutoShape 81"/>
            <p:cNvSpPr/>
            <p:nvPr/>
          </p:nvSpPr>
          <p:spPr>
            <a:xfrm>
              <a:off x="5749920" y="3277800"/>
              <a:ext cx="2006640" cy="508320"/>
            </a:xfrm>
            <a:prstGeom prst="hexagon">
              <a:avLst>
                <a:gd name="adj" fmla="val 0"/>
                <a:gd name="vf" fmla="val 11547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F8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IVS22 Spacer-DN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product (473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AutoShape 82"/>
            <p:cNvSpPr/>
            <p:nvPr/>
          </p:nvSpPr>
          <p:spPr>
            <a:xfrm>
              <a:off x="8861400" y="3277800"/>
              <a:ext cx="2006640" cy="508320"/>
            </a:xfrm>
            <a:prstGeom prst="hexagon">
              <a:avLst>
                <a:gd name="adj" fmla="val 0"/>
                <a:gd name="vf" fmla="val 115470"/>
              </a:avLst>
            </a:prstGeom>
            <a:solidFill>
              <a:srgbClr val="66ff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JAK2 WT-right-ar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product (453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83"/>
            <p:cNvSpPr/>
            <p:nvPr/>
          </p:nvSpPr>
          <p:spPr>
            <a:xfrm>
              <a:off x="7477560" y="4047840"/>
              <a:ext cx="160416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84"/>
            <p:cNvSpPr/>
            <p:nvPr/>
          </p:nvSpPr>
          <p:spPr>
            <a:xfrm>
              <a:off x="7463160" y="4466880"/>
              <a:ext cx="163908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Up-Sp-gDNA + RO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86"/>
            <p:cNvSpPr/>
            <p:nvPr/>
          </p:nvSpPr>
          <p:spPr>
            <a:xfrm>
              <a:off x="4378680" y="4047840"/>
              <a:ext cx="160416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87"/>
            <p:cNvSpPr/>
            <p:nvPr/>
          </p:nvSpPr>
          <p:spPr>
            <a:xfrm>
              <a:off x="4377960" y="4466880"/>
              <a:ext cx="160560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FOin + Lo-Sp-g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89"/>
            <p:cNvSpPr/>
            <p:nvPr/>
          </p:nvSpPr>
          <p:spPr>
            <a:xfrm>
              <a:off x="5928120" y="5991120"/>
              <a:ext cx="160416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90"/>
            <p:cNvSpPr/>
            <p:nvPr/>
          </p:nvSpPr>
          <p:spPr>
            <a:xfrm>
              <a:off x="6243840" y="6410160"/>
              <a:ext cx="106632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FOin + RO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94"/>
            <p:cNvSpPr/>
            <p:nvPr/>
          </p:nvSpPr>
          <p:spPr>
            <a:xfrm>
              <a:off x="4835520" y="5208480"/>
              <a:ext cx="1638360" cy="507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AutoShape 88"/>
            <p:cNvSpPr/>
            <p:nvPr/>
          </p:nvSpPr>
          <p:spPr>
            <a:xfrm>
              <a:off x="3171960" y="5208480"/>
              <a:ext cx="3301920" cy="507960"/>
            </a:xfrm>
            <a:prstGeom prst="hexagon">
              <a:avLst>
                <a:gd name="adj" fmla="val 0"/>
                <a:gd name="vf" fmla="val 11547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MT-arm :: Spacer-DN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product (775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95"/>
            <p:cNvSpPr/>
            <p:nvPr/>
          </p:nvSpPr>
          <p:spPr>
            <a:xfrm>
              <a:off x="7020000" y="5221080"/>
              <a:ext cx="1600200" cy="495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AutoShape 85"/>
            <p:cNvSpPr/>
            <p:nvPr/>
          </p:nvSpPr>
          <p:spPr>
            <a:xfrm>
              <a:off x="7007040" y="5208480"/>
              <a:ext cx="3441960" cy="507960"/>
            </a:xfrm>
            <a:prstGeom prst="hexagon">
              <a:avLst>
                <a:gd name="adj" fmla="val 0"/>
                <a:gd name="vf" fmla="val 11547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Spacer-DNA :: </a:t>
              </a: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WT-ar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product (781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96"/>
            <p:cNvSpPr/>
            <p:nvPr/>
          </p:nvSpPr>
          <p:spPr>
            <a:xfrm>
              <a:off x="3641760" y="7151400"/>
              <a:ext cx="2387520" cy="59688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97"/>
            <p:cNvSpPr/>
            <p:nvPr/>
          </p:nvSpPr>
          <p:spPr>
            <a:xfrm>
              <a:off x="7464240" y="7151400"/>
              <a:ext cx="2362320" cy="609840"/>
            </a:xfrm>
            <a:prstGeom prst="rect">
              <a:avLst/>
            </a:prstGeom>
            <a:solidFill>
              <a:srgbClr val="66ff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98"/>
            <p:cNvSpPr/>
            <p:nvPr/>
          </p:nvSpPr>
          <p:spPr>
            <a:xfrm>
              <a:off x="6041880" y="7151400"/>
              <a:ext cx="1422360" cy="596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AutoShape 91"/>
            <p:cNvSpPr/>
            <p:nvPr/>
          </p:nvSpPr>
          <p:spPr>
            <a:xfrm>
              <a:off x="3629160" y="7138800"/>
              <a:ext cx="6197400" cy="622440"/>
            </a:xfrm>
            <a:prstGeom prst="hexagon">
              <a:avLst>
                <a:gd name="adj" fmla="val 0"/>
                <a:gd name="vf" fmla="val 11547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MT-arm   : :    Spacer - DNA   : :   </a:t>
              </a: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WT-ar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1::1 gDNA construct PCR product (1083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cloned/amplifi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4" name="Text Box 103"/>
          <p:cNvSpPr/>
          <p:nvPr/>
        </p:nvSpPr>
        <p:spPr>
          <a:xfrm>
            <a:off x="1270080" y="2457360"/>
            <a:ext cx="100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1st seri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104"/>
          <p:cNvSpPr/>
          <p:nvPr/>
        </p:nvSpPr>
        <p:spPr>
          <a:xfrm>
            <a:off x="2053080" y="4329000"/>
            <a:ext cx="106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2nd seri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05"/>
          <p:cNvSpPr/>
          <p:nvPr/>
        </p:nvSpPr>
        <p:spPr>
          <a:xfrm>
            <a:off x="3216600" y="6245280"/>
            <a:ext cx="102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3rd seri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106"/>
          <p:cNvSpPr/>
          <p:nvPr/>
        </p:nvSpPr>
        <p:spPr>
          <a:xfrm>
            <a:off x="3448440" y="3795840"/>
            <a:ext cx="34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(i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107"/>
          <p:cNvSpPr/>
          <p:nvPr/>
        </p:nvSpPr>
        <p:spPr>
          <a:xfrm>
            <a:off x="6553080" y="3794040"/>
            <a:ext cx="400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(ii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108"/>
          <p:cNvSpPr/>
          <p:nvPr/>
        </p:nvSpPr>
        <p:spPr>
          <a:xfrm>
            <a:off x="9702360" y="3808440"/>
            <a:ext cx="45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(iii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109"/>
          <p:cNvSpPr/>
          <p:nvPr/>
        </p:nvSpPr>
        <p:spPr>
          <a:xfrm>
            <a:off x="4638600" y="5753160"/>
            <a:ext cx="44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(iv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110"/>
          <p:cNvSpPr/>
          <p:nvPr/>
        </p:nvSpPr>
        <p:spPr>
          <a:xfrm>
            <a:off x="8484480" y="5738760"/>
            <a:ext cx="3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(v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52 CuadroTexto"/>
          <p:cNvSpPr/>
          <p:nvPr/>
        </p:nvSpPr>
        <p:spPr>
          <a:xfrm>
            <a:off x="1047960" y="933480"/>
            <a:ext cx="3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Group 62"/>
          <p:cNvGrpSpPr/>
          <p:nvPr/>
        </p:nvGrpSpPr>
        <p:grpSpPr>
          <a:xfrm>
            <a:off x="1138320" y="1411200"/>
            <a:ext cx="10459800" cy="6397200"/>
            <a:chOff x="1138320" y="1411200"/>
            <a:chExt cx="10459800" cy="6397200"/>
          </a:xfrm>
        </p:grpSpPr>
        <p:sp>
          <p:nvSpPr>
            <p:cNvPr id="94" name="Rectangle 63"/>
            <p:cNvSpPr/>
            <p:nvPr/>
          </p:nvSpPr>
          <p:spPr>
            <a:xfrm>
              <a:off x="8273880" y="5256000"/>
              <a:ext cx="1803600" cy="507600"/>
            </a:xfrm>
            <a:prstGeom prst="rect">
              <a:avLst/>
            </a:prstGeom>
            <a:solidFill>
              <a:srgbClr val="66ff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64"/>
            <p:cNvSpPr/>
            <p:nvPr/>
          </p:nvSpPr>
          <p:spPr>
            <a:xfrm>
              <a:off x="2800440" y="5256000"/>
              <a:ext cx="1663560" cy="50760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6" name="Group 65"/>
            <p:cNvGrpSpPr/>
            <p:nvPr/>
          </p:nvGrpSpPr>
          <p:grpSpPr>
            <a:xfrm>
              <a:off x="5842080" y="5567040"/>
              <a:ext cx="1103760" cy="1580760"/>
              <a:chOff x="5842080" y="5567040"/>
              <a:chExt cx="1103760" cy="1580760"/>
            </a:xfrm>
          </p:grpSpPr>
          <p:sp>
            <p:nvSpPr>
              <p:cNvPr id="97" name="AutoShape 66"/>
              <p:cNvSpPr/>
              <p:nvPr/>
            </p:nvSpPr>
            <p:spPr>
              <a:xfrm>
                <a:off x="6191280" y="5918760"/>
                <a:ext cx="354960" cy="1229040"/>
              </a:xfrm>
              <a:prstGeom prst="downArrow">
                <a:avLst>
                  <a:gd name="adj1" fmla="val 50000"/>
                  <a:gd name="adj2" fmla="val 55079"/>
                </a:avLst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AutoShape 67"/>
              <p:cNvSpPr/>
              <p:nvPr/>
            </p:nvSpPr>
            <p:spPr>
              <a:xfrm rot="5400000">
                <a:off x="5846040" y="5562720"/>
                <a:ext cx="693000" cy="701280"/>
              </a:xfrm>
              <a:custGeom>
                <a:avLst/>
                <a:gdLst>
                  <a:gd name="textAreaLeft" fmla="*/ 399600 w 693000"/>
                  <a:gd name="textAreaRight" fmla="*/ 687240 w 693000"/>
                  <a:gd name="textAreaTop" fmla="*/ 102960 h 701280"/>
                  <a:gd name="textAreaBottom" fmla="*/ 291960 h 701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AutoShape 68"/>
              <p:cNvSpPr/>
              <p:nvPr/>
            </p:nvSpPr>
            <p:spPr>
              <a:xfrm flipH="1" rot="16200000">
                <a:off x="6200640" y="5515200"/>
                <a:ext cx="693000" cy="796680"/>
              </a:xfrm>
              <a:custGeom>
                <a:avLst/>
                <a:gdLst>
                  <a:gd name="textAreaLeft" fmla="*/ 399600 w 693000"/>
                  <a:gd name="textAreaRight" fmla="*/ 687240 w 693000"/>
                  <a:gd name="textAreaTop" fmla="*/ 117360 h 796680"/>
                  <a:gd name="textAreaBottom" fmla="*/ 331560 h 796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0" name="Group 69"/>
            <p:cNvGrpSpPr/>
            <p:nvPr/>
          </p:nvGrpSpPr>
          <p:grpSpPr>
            <a:xfrm>
              <a:off x="7391520" y="3623760"/>
              <a:ext cx="1103760" cy="1580760"/>
              <a:chOff x="7391520" y="3623760"/>
              <a:chExt cx="1103760" cy="1580760"/>
            </a:xfrm>
          </p:grpSpPr>
          <p:sp>
            <p:nvSpPr>
              <p:cNvPr id="101" name="AutoShape 70"/>
              <p:cNvSpPr/>
              <p:nvPr/>
            </p:nvSpPr>
            <p:spPr>
              <a:xfrm>
                <a:off x="7740720" y="3975480"/>
                <a:ext cx="354960" cy="1229040"/>
              </a:xfrm>
              <a:prstGeom prst="downArrow">
                <a:avLst>
                  <a:gd name="adj1" fmla="val 50000"/>
                  <a:gd name="adj2" fmla="val 55079"/>
                </a:avLst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AutoShape 71"/>
              <p:cNvSpPr/>
              <p:nvPr/>
            </p:nvSpPr>
            <p:spPr>
              <a:xfrm rot="5400000">
                <a:off x="7395480" y="3619800"/>
                <a:ext cx="693360" cy="701280"/>
              </a:xfrm>
              <a:custGeom>
                <a:avLst/>
                <a:gdLst>
                  <a:gd name="textAreaLeft" fmla="*/ 399600 w 693360"/>
                  <a:gd name="textAreaRight" fmla="*/ 687600 w 693360"/>
                  <a:gd name="textAreaTop" fmla="*/ 102960 h 701280"/>
                  <a:gd name="textAreaBottom" fmla="*/ 291960 h 701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AutoShape 72"/>
              <p:cNvSpPr/>
              <p:nvPr/>
            </p:nvSpPr>
            <p:spPr>
              <a:xfrm flipH="1" rot="16200000">
                <a:off x="7749720" y="3571920"/>
                <a:ext cx="693360" cy="796680"/>
              </a:xfrm>
              <a:custGeom>
                <a:avLst/>
                <a:gdLst>
                  <a:gd name="textAreaLeft" fmla="*/ 399600 w 693360"/>
                  <a:gd name="textAreaRight" fmla="*/ 687600 w 693360"/>
                  <a:gd name="textAreaTop" fmla="*/ 117360 h 796680"/>
                  <a:gd name="textAreaBottom" fmla="*/ 331560 h 796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4" name="Group 73"/>
            <p:cNvGrpSpPr/>
            <p:nvPr/>
          </p:nvGrpSpPr>
          <p:grpSpPr>
            <a:xfrm>
              <a:off x="4280040" y="3623760"/>
              <a:ext cx="1103760" cy="1580760"/>
              <a:chOff x="4280040" y="3623760"/>
              <a:chExt cx="1103760" cy="1580760"/>
            </a:xfrm>
          </p:grpSpPr>
          <p:sp>
            <p:nvSpPr>
              <p:cNvPr id="105" name="AutoShape 74"/>
              <p:cNvSpPr/>
              <p:nvPr/>
            </p:nvSpPr>
            <p:spPr>
              <a:xfrm>
                <a:off x="4629240" y="3975480"/>
                <a:ext cx="354960" cy="1229040"/>
              </a:xfrm>
              <a:prstGeom prst="downArrow">
                <a:avLst>
                  <a:gd name="adj1" fmla="val 50000"/>
                  <a:gd name="adj2" fmla="val 55079"/>
                </a:avLst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AutoShape 75"/>
              <p:cNvSpPr/>
              <p:nvPr/>
            </p:nvSpPr>
            <p:spPr>
              <a:xfrm rot="5400000">
                <a:off x="4284000" y="3619800"/>
                <a:ext cx="693360" cy="701280"/>
              </a:xfrm>
              <a:custGeom>
                <a:avLst/>
                <a:gdLst>
                  <a:gd name="textAreaLeft" fmla="*/ 399600 w 693360"/>
                  <a:gd name="textAreaRight" fmla="*/ 687600 w 693360"/>
                  <a:gd name="textAreaTop" fmla="*/ 102960 h 701280"/>
                  <a:gd name="textAreaBottom" fmla="*/ 291960 h 701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AutoShape 76"/>
              <p:cNvSpPr/>
              <p:nvPr/>
            </p:nvSpPr>
            <p:spPr>
              <a:xfrm flipH="1" rot="16200000">
                <a:off x="4638240" y="3571920"/>
                <a:ext cx="693360" cy="796680"/>
              </a:xfrm>
              <a:custGeom>
                <a:avLst/>
                <a:gdLst>
                  <a:gd name="textAreaLeft" fmla="*/ 399600 w 693360"/>
                  <a:gd name="textAreaRight" fmla="*/ 687600 w 693360"/>
                  <a:gd name="textAreaTop" fmla="*/ 117360 h 796680"/>
                  <a:gd name="textAreaBottom" fmla="*/ 331560 h 796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6079"/>
                    </a:moveTo>
                    <a:lnTo>
                      <a:pt x="21246" y="0"/>
                    </a:lnTo>
                    <a:lnTo>
                      <a:pt x="21246" y="3176"/>
                    </a:lnTo>
                    <a:lnTo>
                      <a:pt x="12427" y="3176"/>
                    </a:lnTo>
                    <a:cubicBezTo>
                      <a:pt x="5564" y="3176"/>
                      <a:pt x="0" y="7197"/>
                      <a:pt x="0" y="12158"/>
                    </a:cubicBezTo>
                    <a:lnTo>
                      <a:pt x="0" y="21600"/>
                    </a:lnTo>
                    <a:lnTo>
                      <a:pt x="5934" y="21600"/>
                    </a:lnTo>
                    <a:lnTo>
                      <a:pt x="5934" y="12158"/>
                    </a:lnTo>
                    <a:cubicBezTo>
                      <a:pt x="5934" y="10404"/>
                      <a:pt x="8841" y="8982"/>
                      <a:pt x="12427" y="8982"/>
                    </a:cubicBezTo>
                    <a:lnTo>
                      <a:pt x="21246" y="8982"/>
                    </a:lnTo>
                    <a:lnTo>
                      <a:pt x="21246" y="12158"/>
                    </a:lnTo>
                    <a:lnTo>
                      <a:pt x="21600" y="6079"/>
                    </a:lnTo>
                    <a:close/>
                  </a:path>
                </a:pathLst>
              </a:cu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8" name="AutoShape 77"/>
            <p:cNvSpPr/>
            <p:nvPr/>
          </p:nvSpPr>
          <p:spPr>
            <a:xfrm>
              <a:off x="3092400" y="1966680"/>
              <a:ext cx="355680" cy="1307520"/>
            </a:xfrm>
            <a:prstGeom prst="downArrow">
              <a:avLst>
                <a:gd name="adj1" fmla="val 50000"/>
                <a:gd name="adj2" fmla="val 58477"/>
              </a:avLst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AutoShape 78"/>
            <p:cNvSpPr/>
            <p:nvPr/>
          </p:nvSpPr>
          <p:spPr>
            <a:xfrm>
              <a:off x="6216480" y="1966680"/>
              <a:ext cx="355680" cy="1307520"/>
            </a:xfrm>
            <a:prstGeom prst="downArrow">
              <a:avLst>
                <a:gd name="adj1" fmla="val 50000"/>
                <a:gd name="adj2" fmla="val 58477"/>
              </a:avLst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AutoShape 79"/>
            <p:cNvSpPr/>
            <p:nvPr/>
          </p:nvSpPr>
          <p:spPr>
            <a:xfrm>
              <a:off x="9302760" y="1966680"/>
              <a:ext cx="355680" cy="1307520"/>
            </a:xfrm>
            <a:prstGeom prst="downArrow">
              <a:avLst>
                <a:gd name="adj1" fmla="val 50000"/>
                <a:gd name="adj2" fmla="val 58477"/>
              </a:avLst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AutoShape 80"/>
            <p:cNvSpPr/>
            <p:nvPr/>
          </p:nvSpPr>
          <p:spPr>
            <a:xfrm>
              <a:off x="1254240" y="1458720"/>
              <a:ext cx="3238560" cy="507600"/>
            </a:xfrm>
            <a:prstGeom prst="hexagon">
              <a:avLst>
                <a:gd name="adj" fmla="val 30572"/>
                <a:gd name="vf" fmla="val 115470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p.V617F homozygous patient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Complementary DNA samp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AutoShape 81"/>
            <p:cNvSpPr/>
            <p:nvPr/>
          </p:nvSpPr>
          <p:spPr>
            <a:xfrm>
              <a:off x="8288280" y="1458720"/>
              <a:ext cx="3309840" cy="507600"/>
            </a:xfrm>
            <a:prstGeom prst="hexagon">
              <a:avLst>
                <a:gd name="adj" fmla="val 35018"/>
                <a:gd name="vf" fmla="val 115470"/>
              </a:avLst>
            </a:prstGeom>
            <a:solidFill>
              <a:srgbClr val="66ff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Wild-type individua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Complementary DNA samp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82"/>
            <p:cNvSpPr/>
            <p:nvPr/>
          </p:nvSpPr>
          <p:spPr>
            <a:xfrm>
              <a:off x="2634480" y="2177640"/>
              <a:ext cx="132516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c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83"/>
            <p:cNvSpPr/>
            <p:nvPr/>
          </p:nvSpPr>
          <p:spPr>
            <a:xfrm>
              <a:off x="2772000" y="2533320"/>
              <a:ext cx="106632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FO-1 + RO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84"/>
            <p:cNvSpPr/>
            <p:nvPr/>
          </p:nvSpPr>
          <p:spPr>
            <a:xfrm>
              <a:off x="8844840" y="2177640"/>
              <a:ext cx="132516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c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85"/>
            <p:cNvSpPr/>
            <p:nvPr/>
          </p:nvSpPr>
          <p:spPr>
            <a:xfrm>
              <a:off x="8956800" y="2533320"/>
              <a:ext cx="106632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FO-1 + RO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86"/>
            <p:cNvSpPr/>
            <p:nvPr/>
          </p:nvSpPr>
          <p:spPr>
            <a:xfrm>
              <a:off x="5766120" y="2177640"/>
              <a:ext cx="133272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g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87"/>
            <p:cNvSpPr/>
            <p:nvPr/>
          </p:nvSpPr>
          <p:spPr>
            <a:xfrm>
              <a:off x="5248440" y="2533320"/>
              <a:ext cx="231912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Up-Sp-cDNA + Lo-Sp-c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AutoShape 88"/>
            <p:cNvSpPr/>
            <p:nvPr/>
          </p:nvSpPr>
          <p:spPr>
            <a:xfrm>
              <a:off x="2292480" y="3325320"/>
              <a:ext cx="2006640" cy="507960"/>
            </a:xfrm>
            <a:prstGeom prst="hexagon">
              <a:avLst>
                <a:gd name="adj" fmla="val 0"/>
                <a:gd name="vf" fmla="val 115470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MT Right-MT-ar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product (371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AutoShape 89"/>
            <p:cNvSpPr/>
            <p:nvPr/>
          </p:nvSpPr>
          <p:spPr>
            <a:xfrm>
              <a:off x="5378400" y="3325320"/>
              <a:ext cx="2006640" cy="507960"/>
            </a:xfrm>
            <a:prstGeom prst="hexagon">
              <a:avLst>
                <a:gd name="adj" fmla="val 0"/>
                <a:gd name="vf" fmla="val 11547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F8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IVS22 Spacer-DN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product (473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AutoShape 90"/>
            <p:cNvSpPr/>
            <p:nvPr/>
          </p:nvSpPr>
          <p:spPr>
            <a:xfrm>
              <a:off x="8489880" y="3325320"/>
              <a:ext cx="2006640" cy="507960"/>
            </a:xfrm>
            <a:prstGeom prst="hexagon">
              <a:avLst>
                <a:gd name="adj" fmla="val 0"/>
                <a:gd name="vf" fmla="val 115470"/>
              </a:avLst>
            </a:prstGeom>
            <a:solidFill>
              <a:srgbClr val="66ff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JAK2 WT Left-ar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product (371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91"/>
            <p:cNvSpPr/>
            <p:nvPr/>
          </p:nvSpPr>
          <p:spPr>
            <a:xfrm>
              <a:off x="7106040" y="4095360"/>
              <a:ext cx="160416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92"/>
            <p:cNvSpPr/>
            <p:nvPr/>
          </p:nvSpPr>
          <p:spPr>
            <a:xfrm>
              <a:off x="7089840" y="4514400"/>
              <a:ext cx="163152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Up-Sp-cDNA + RO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93"/>
            <p:cNvSpPr/>
            <p:nvPr/>
          </p:nvSpPr>
          <p:spPr>
            <a:xfrm>
              <a:off x="4007160" y="4095360"/>
              <a:ext cx="160416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94"/>
            <p:cNvSpPr/>
            <p:nvPr/>
          </p:nvSpPr>
          <p:spPr>
            <a:xfrm>
              <a:off x="4004640" y="4514400"/>
              <a:ext cx="159804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FO-1 + Lo-Sp-c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95"/>
            <p:cNvSpPr/>
            <p:nvPr/>
          </p:nvSpPr>
          <p:spPr>
            <a:xfrm>
              <a:off x="5556600" y="6038640"/>
              <a:ext cx="1604160" cy="27648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DNA subst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96"/>
            <p:cNvSpPr/>
            <p:nvPr/>
          </p:nvSpPr>
          <p:spPr>
            <a:xfrm>
              <a:off x="5870880" y="6457680"/>
              <a:ext cx="1066320" cy="276480"/>
            </a:xfrm>
            <a:prstGeom prst="rect">
              <a:avLst/>
            </a:prstGeom>
            <a:solidFill>
              <a:srgbClr val="f8f8f8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FO-1 + RO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97"/>
            <p:cNvSpPr/>
            <p:nvPr/>
          </p:nvSpPr>
          <p:spPr>
            <a:xfrm>
              <a:off x="4464000" y="5256000"/>
              <a:ext cx="1638360" cy="507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AutoShape 98"/>
            <p:cNvSpPr/>
            <p:nvPr/>
          </p:nvSpPr>
          <p:spPr>
            <a:xfrm>
              <a:off x="2800440" y="5256000"/>
              <a:ext cx="3301920" cy="507600"/>
            </a:xfrm>
            <a:prstGeom prst="hexagon">
              <a:avLst>
                <a:gd name="adj" fmla="val 0"/>
                <a:gd name="vf" fmla="val 11547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MT-arm :: Spacer-DN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product (752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99"/>
            <p:cNvSpPr/>
            <p:nvPr/>
          </p:nvSpPr>
          <p:spPr>
            <a:xfrm>
              <a:off x="6648480" y="5268600"/>
              <a:ext cx="1600200" cy="495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AutoShape 100"/>
            <p:cNvSpPr/>
            <p:nvPr/>
          </p:nvSpPr>
          <p:spPr>
            <a:xfrm>
              <a:off x="6635880" y="5256000"/>
              <a:ext cx="3441600" cy="507600"/>
            </a:xfrm>
            <a:prstGeom prst="hexagon">
              <a:avLst>
                <a:gd name="adj" fmla="val 0"/>
                <a:gd name="vf" fmla="val 11547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Spacer-DNA :: </a:t>
              </a: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WT-ar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PCR product (743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101"/>
            <p:cNvSpPr/>
            <p:nvPr/>
          </p:nvSpPr>
          <p:spPr>
            <a:xfrm>
              <a:off x="3270240" y="7198920"/>
              <a:ext cx="2387520" cy="5965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102"/>
            <p:cNvSpPr/>
            <p:nvPr/>
          </p:nvSpPr>
          <p:spPr>
            <a:xfrm>
              <a:off x="7093080" y="7198920"/>
              <a:ext cx="2361960" cy="609480"/>
            </a:xfrm>
            <a:prstGeom prst="rect">
              <a:avLst/>
            </a:prstGeom>
            <a:solidFill>
              <a:srgbClr val="66ff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103"/>
            <p:cNvSpPr/>
            <p:nvPr/>
          </p:nvSpPr>
          <p:spPr>
            <a:xfrm>
              <a:off x="5670720" y="7198920"/>
              <a:ext cx="1422360" cy="596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AutoShape 104"/>
            <p:cNvSpPr/>
            <p:nvPr/>
          </p:nvSpPr>
          <p:spPr>
            <a:xfrm>
              <a:off x="3257640" y="7186320"/>
              <a:ext cx="6197400" cy="622080"/>
            </a:xfrm>
            <a:prstGeom prst="hexagon">
              <a:avLst>
                <a:gd name="adj" fmla="val 0"/>
                <a:gd name="vf" fmla="val 11547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MT-arm   : :    Spacer - DNA   : :   </a:t>
              </a: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WT-ar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1::1 cDNA construct PCR product (1023 b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cloned/amplifi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AutoShape 105"/>
            <p:cNvSpPr/>
            <p:nvPr/>
          </p:nvSpPr>
          <p:spPr>
            <a:xfrm flipH="1">
              <a:off x="1138320" y="1411200"/>
              <a:ext cx="333360" cy="609480"/>
            </a:xfrm>
            <a:prstGeom prst="flowChartDelay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AutoShape 106"/>
            <p:cNvSpPr/>
            <p:nvPr/>
          </p:nvSpPr>
          <p:spPr>
            <a:xfrm flipH="1">
              <a:off x="8255160" y="1412640"/>
              <a:ext cx="333360" cy="609120"/>
            </a:xfrm>
            <a:prstGeom prst="flowChartDelay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AutoShape 107"/>
            <p:cNvSpPr/>
            <p:nvPr/>
          </p:nvSpPr>
          <p:spPr>
            <a:xfrm>
              <a:off x="4802040" y="1458720"/>
              <a:ext cx="3179880" cy="507600"/>
            </a:xfrm>
            <a:prstGeom prst="hexagon">
              <a:avLst>
                <a:gd name="adj" fmla="val 26885"/>
                <a:gd name="vf" fmla="val 11547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i="1" lang="es-AR" sz="1200" spc="-1" strike="noStrike">
                  <a:solidFill>
                    <a:srgbClr val="000000"/>
                  </a:solidFill>
                  <a:latin typeface="Arial"/>
                </a:rPr>
                <a:t>JAK2</a:t>
              </a: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 Wild-type individua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1" lang="es-AR" sz="1200" spc="-1" strike="noStrike">
                  <a:solidFill>
                    <a:srgbClr val="000000"/>
                  </a:solidFill>
                  <a:latin typeface="Arial"/>
                </a:rPr>
                <a:t>Genomic DNA samp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9" name="Text Box 110"/>
          <p:cNvSpPr/>
          <p:nvPr/>
        </p:nvSpPr>
        <p:spPr>
          <a:xfrm>
            <a:off x="1370160" y="2676600"/>
            <a:ext cx="100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1st seri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111"/>
          <p:cNvSpPr/>
          <p:nvPr/>
        </p:nvSpPr>
        <p:spPr>
          <a:xfrm>
            <a:off x="2053080" y="4491000"/>
            <a:ext cx="106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2nd seri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112"/>
          <p:cNvSpPr/>
          <p:nvPr/>
        </p:nvSpPr>
        <p:spPr>
          <a:xfrm>
            <a:off x="3145320" y="6407280"/>
            <a:ext cx="102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3rd seri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113"/>
          <p:cNvSpPr/>
          <p:nvPr/>
        </p:nvSpPr>
        <p:spPr>
          <a:xfrm>
            <a:off x="3076560" y="3886200"/>
            <a:ext cx="400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(i’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114"/>
          <p:cNvSpPr/>
          <p:nvPr/>
        </p:nvSpPr>
        <p:spPr>
          <a:xfrm>
            <a:off x="6224040" y="3884760"/>
            <a:ext cx="45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(ii’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115"/>
          <p:cNvSpPr/>
          <p:nvPr/>
        </p:nvSpPr>
        <p:spPr>
          <a:xfrm>
            <a:off x="9344520" y="3898800"/>
            <a:ext cx="50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(iii’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116"/>
          <p:cNvSpPr/>
          <p:nvPr/>
        </p:nvSpPr>
        <p:spPr>
          <a:xfrm>
            <a:off x="4295520" y="5829480"/>
            <a:ext cx="49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(iv’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117"/>
          <p:cNvSpPr/>
          <p:nvPr/>
        </p:nvSpPr>
        <p:spPr>
          <a:xfrm>
            <a:off x="8026560" y="5827680"/>
            <a:ext cx="44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222200"/>
                <a:tab algn="l" pos="2444760"/>
                <a:tab algn="l" pos="3666960"/>
                <a:tab algn="l" pos="4889520"/>
                <a:tab algn="l" pos="6111720"/>
                <a:tab algn="l" pos="7334280"/>
                <a:tab algn="l" pos="8556480"/>
                <a:tab algn="l" pos="9779040"/>
              </a:tabLst>
            </a:pPr>
            <a:r>
              <a:rPr b="1" lang="es-AR" sz="1400" spc="-1" strike="noStrike">
                <a:solidFill>
                  <a:srgbClr val="000000"/>
                </a:solidFill>
                <a:latin typeface="Arial"/>
              </a:rPr>
              <a:t>(v’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1 CuadroTexto"/>
          <p:cNvSpPr/>
          <p:nvPr/>
        </p:nvSpPr>
        <p:spPr>
          <a:xfrm>
            <a:off x="1141920" y="952560"/>
            <a:ext cx="3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16T19:34:52Z</dcterms:created>
  <dc:creator>Charlo</dc:creator>
  <dc:description/>
  <dc:language>en-US</dc:language>
  <cp:lastModifiedBy>ilarripa</cp:lastModifiedBy>
  <dcterms:modified xsi:type="dcterms:W3CDTF">2014-01-03T17:23:22Z</dcterms:modified>
  <cp:revision>53</cp:revision>
  <dc:subject/>
  <dc:title>Diapositiva 1</dc:title>
</cp:coreProperties>
</file>